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4C1A8A3-306A-4EB7-A6B1-4F7E0EB9C5D6}" styleName="中度样式 3 - 强调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93" autoAdjust="0"/>
    <p:restoredTop sz="94660"/>
  </p:normalViewPr>
  <p:slideViewPr>
    <p:cSldViewPr snapToGrid="0">
      <p:cViewPr>
        <p:scale>
          <a:sx n="75" d="100"/>
          <a:sy n="75" d="100"/>
        </p:scale>
        <p:origin x="1308" y="7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2381A0-831F-65AD-7C27-CB2A5CCCB2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BC1C3CA-B6DC-0640-724A-AECB811D16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2A418E-D76E-B831-9889-84FD518E99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79BD-DA99-4BF2-997D-D49975883010}" type="datetimeFigureOut">
              <a:rPr lang="zh-CN" altLang="en-US" smtClean="0"/>
              <a:t>2026/1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8048A3-EBB2-4E8B-DDF3-3E209C8DF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78959B-4C12-F9A9-EA5A-93E1880F7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AAB92-3099-42A1-81E6-E5E5A9500E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2969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037A44-F778-3A8A-8301-432FF534C0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6EFAFA5-9924-B2FE-A72E-1CD2AD6864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0FED1DD-546A-51EE-A722-24240C005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79BD-DA99-4BF2-997D-D49975883010}" type="datetimeFigureOut">
              <a:rPr lang="zh-CN" altLang="en-US" smtClean="0"/>
              <a:t>2026/1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7BE541B-BF40-77E1-5167-774DAC168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EB19E6-8C16-F68E-B4EC-BD1040F142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AAB92-3099-42A1-81E6-E5E5A9500E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9568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8C188AA-FDF7-E9AD-9C40-DA2B9643D9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17C28E4-698C-8B29-93A8-8879C059B7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DF1D9D4-96A4-8F42-B8E2-AFABFD157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79BD-DA99-4BF2-997D-D49975883010}" type="datetimeFigureOut">
              <a:rPr lang="zh-CN" altLang="en-US" smtClean="0"/>
              <a:t>2026/1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2BAC4B-F564-F326-0F2E-4DBFB7D5D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6A149D2-CB97-65C6-4156-5EF93FC14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AAB92-3099-42A1-81E6-E5E5A9500E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0697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F187EC-5358-BC17-C277-CE782CD434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B48885F-BE2E-4D8C-4823-D4E6D0B074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F737CDA-35E9-1562-D17D-A2F311DA0B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79BD-DA99-4BF2-997D-D49975883010}" type="datetimeFigureOut">
              <a:rPr lang="zh-CN" altLang="en-US" smtClean="0"/>
              <a:t>2026/1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EBA286-AFAF-1140-4811-C76B29AE2D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C1C5F9-25C8-2D28-FF4D-C11B1BB6D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AAB92-3099-42A1-81E6-E5E5A9500E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4112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515F8E-EB17-34A8-40FB-D6F81716A5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EB467ED-7B70-5003-9D18-5647DA8F82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0E2DF8-EB43-B80B-E5EB-2F88A39D3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79BD-DA99-4BF2-997D-D49975883010}" type="datetimeFigureOut">
              <a:rPr lang="zh-CN" altLang="en-US" smtClean="0"/>
              <a:t>2026/1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845DE3-7032-3847-51E1-CE5FA28CC1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A58579D-B596-D383-B07A-BC8230983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AAB92-3099-42A1-81E6-E5E5A9500E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5885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973690-0C50-DA35-1886-877B4C57EE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071A1C0-D8F4-D6E8-35F9-E7180645C9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D867B45-06F2-A91B-FF52-DAD4D21F16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0E11634-1D9B-8D33-8A45-C8049A0C1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79BD-DA99-4BF2-997D-D49975883010}" type="datetimeFigureOut">
              <a:rPr lang="zh-CN" altLang="en-US" smtClean="0"/>
              <a:t>2026/1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0B5A733-606B-F262-980A-E0164B259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6C82FA5-93FF-C4C0-14CF-86BAB4693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AAB92-3099-42A1-81E6-E5E5A9500E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6623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882D37-705B-2D72-9896-460C599A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11B5419-EC09-E9AF-2B58-7B205BB0FB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078BF44-4724-DE78-8666-6A6E0DE5F5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237F199-7D15-2F5E-2D1E-43720C80D9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CDC0311-D341-25ED-5E3C-874432C616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D065A1B-2F22-90B8-6E1C-120515113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79BD-DA99-4BF2-997D-D49975883010}" type="datetimeFigureOut">
              <a:rPr lang="zh-CN" altLang="en-US" smtClean="0"/>
              <a:t>2026/1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7C49A52-20EB-A69E-819E-8DEF46523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8EB1F98-E8A4-DA4E-049C-14101594B0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AAB92-3099-42A1-81E6-E5E5A9500E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6625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55C34-7116-082A-4FE4-732CB99E19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4E2684D-6354-A420-ADF8-15E05251EC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79BD-DA99-4BF2-997D-D49975883010}" type="datetimeFigureOut">
              <a:rPr lang="zh-CN" altLang="en-US" smtClean="0"/>
              <a:t>2026/1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FCE3EF0-0DDC-72F4-81E9-24D9A96E90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9C20E2D-4608-63A1-C18F-3E204ADC7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AAB92-3099-42A1-81E6-E5E5A9500E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4216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3C339CB-7B86-148C-883E-13030DB951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79BD-DA99-4BF2-997D-D49975883010}" type="datetimeFigureOut">
              <a:rPr lang="zh-CN" altLang="en-US" smtClean="0"/>
              <a:t>2026/1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0AF4298-BE5E-4117-3BFF-E0DC4BD79B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36D3244-92E9-3620-FE1D-23CA57F1A7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AAB92-3099-42A1-81E6-E5E5A9500E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7122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BF666F-6B7F-4B83-10CE-AFBD0E1182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8424A10-A211-7DDB-BA39-64DE84FEFF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4241C8A-0DAB-257E-7F5C-87646E0BBB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1B38289-34E2-A386-B14A-7D066776CA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79BD-DA99-4BF2-997D-D49975883010}" type="datetimeFigureOut">
              <a:rPr lang="zh-CN" altLang="en-US" smtClean="0"/>
              <a:t>2026/1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27F00FD-D278-D543-D2C4-0DBC9D6FB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141CC2F-0D4B-F71C-88CB-BD7CF345C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AAB92-3099-42A1-81E6-E5E5A9500E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2138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683EC9-F3F0-B218-7163-FD7EE8A86D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7BC6ED1-A877-B3BA-A7BA-5B77579B88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CDBEA83-BDCD-CC8D-54B8-3FC726960E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0B682BC-8443-FCB2-4955-E1F03F3E3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79BD-DA99-4BF2-997D-D49975883010}" type="datetimeFigureOut">
              <a:rPr lang="zh-CN" altLang="en-US" smtClean="0"/>
              <a:t>2026/1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3F4C6AC-93E3-6F99-39A8-F4B9CE890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86267D5-6FCC-63E4-CE14-11C151EB5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AAB92-3099-42A1-81E6-E5E5A9500E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6611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76BA798-D904-C6BE-2BBE-A41E87D346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ED6A30C-8C65-3320-D7CF-0D86E050F6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3DCC9C-4B19-A602-03EB-F7CE1064AD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479BD-DA99-4BF2-997D-D49975883010}" type="datetimeFigureOut">
              <a:rPr lang="zh-CN" altLang="en-US" smtClean="0"/>
              <a:t>2026/1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15B0DB-D665-422A-B863-1C4727246A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E720C7E-EEF8-9BEF-4D88-4A71D2C19C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7AAB92-3099-42A1-81E6-E5E5A9500E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2286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6D8B0C64-F3EE-5AD5-D763-FC96C506DE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8099685"/>
              </p:ext>
            </p:extLst>
          </p:nvPr>
        </p:nvGraphicFramePr>
        <p:xfrm>
          <a:off x="0" y="454660"/>
          <a:ext cx="12192000" cy="3402753"/>
        </p:xfrm>
        <a:graphic>
          <a:graphicData uri="http://schemas.openxmlformats.org/drawingml/2006/table">
            <a:tbl>
              <a:tblPr firstRow="1" bandRow="1">
                <a:tableStyleId>{74C1A8A3-306A-4EB7-A6B1-4F7E0EB9C5D6}</a:tableStyleId>
              </a:tblPr>
              <a:tblGrid>
                <a:gridCol w="2173504">
                  <a:extLst>
                    <a:ext uri="{9D8B030D-6E8A-4147-A177-3AD203B41FA5}">
                      <a16:colId xmlns:a16="http://schemas.microsoft.com/office/drawing/2014/main" val="1775229026"/>
                    </a:ext>
                  </a:extLst>
                </a:gridCol>
                <a:gridCol w="2224445">
                  <a:extLst>
                    <a:ext uri="{9D8B030D-6E8A-4147-A177-3AD203B41FA5}">
                      <a16:colId xmlns:a16="http://schemas.microsoft.com/office/drawing/2014/main" val="2475946344"/>
                    </a:ext>
                  </a:extLst>
                </a:gridCol>
                <a:gridCol w="1290519">
                  <a:extLst>
                    <a:ext uri="{9D8B030D-6E8A-4147-A177-3AD203B41FA5}">
                      <a16:colId xmlns:a16="http://schemas.microsoft.com/office/drawing/2014/main" val="1483003318"/>
                    </a:ext>
                  </a:extLst>
                </a:gridCol>
                <a:gridCol w="1341459">
                  <a:extLst>
                    <a:ext uri="{9D8B030D-6E8A-4147-A177-3AD203B41FA5}">
                      <a16:colId xmlns:a16="http://schemas.microsoft.com/office/drawing/2014/main" val="3333493838"/>
                    </a:ext>
                  </a:extLst>
                </a:gridCol>
                <a:gridCol w="5162073">
                  <a:extLst>
                    <a:ext uri="{9D8B030D-6E8A-4147-A177-3AD203B41FA5}">
                      <a16:colId xmlns:a16="http://schemas.microsoft.com/office/drawing/2014/main" val="3499699900"/>
                    </a:ext>
                  </a:extLst>
                </a:gridCol>
              </a:tblGrid>
              <a:tr h="80687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xicity Category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sessment Endpoin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dic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 / Probability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sk Interpretation &amp; Relevance to Hypoxia Therapy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240416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diotoxicit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G Inhibi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activ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risk. A key safety advantage for chronic administration in hypoxic conditions.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0490045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cinogenicit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cinogenicit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activ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risk. Favorable for long-term treatment of chronic hypoxia-related diseases.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6380819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ute Toxicit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al LD50 (Rat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Toxicit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65 mg/k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risk. Wide acute safety margin, beneficial for therapeutic dose determination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5896371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chanism-Based Toxicit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tochondrial Toxicity (MMP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ac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t Advantage. Lack of intrinsic mitochondrial toxicity is crucial for a drug aiming to improve cellular energy metabolism under hypoxia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0348828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xidative Stress (ARE Pathway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ac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vantage. Unlikely to induce significant oxidative stress, avoiding exacerbation of hypoxic injury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180373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crine Disruption (AR, ER, AhR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activ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0.90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vantage. No predicted interference with major hormonal pathways, suitable for prolonged use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6645566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Organ Toxicit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phrotoxicit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ac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risk. Reduces concerns for multi-organ damage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232195232"/>
                  </a:ext>
                </a:extLst>
              </a:tr>
            </a:tbl>
          </a:graphicData>
        </a:graphic>
      </p:graphicFrame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54B702CE-4E51-B150-8901-6E127A1505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0782257"/>
              </p:ext>
            </p:extLst>
          </p:nvPr>
        </p:nvGraphicFramePr>
        <p:xfrm>
          <a:off x="0" y="5153025"/>
          <a:ext cx="12192002" cy="1177713"/>
        </p:xfrm>
        <a:graphic>
          <a:graphicData uri="http://schemas.openxmlformats.org/drawingml/2006/table">
            <a:tbl>
              <a:tblPr firstRow="1" bandRow="1">
                <a:tableStyleId>{74C1A8A3-306A-4EB7-A6B1-4F7E0EB9C5D6}</a:tableStyleId>
              </a:tblPr>
              <a:tblGrid>
                <a:gridCol w="1416131">
                  <a:extLst>
                    <a:ext uri="{9D8B030D-6E8A-4147-A177-3AD203B41FA5}">
                      <a16:colId xmlns:a16="http://schemas.microsoft.com/office/drawing/2014/main" val="605375531"/>
                    </a:ext>
                  </a:extLst>
                </a:gridCol>
                <a:gridCol w="1284736">
                  <a:extLst>
                    <a:ext uri="{9D8B030D-6E8A-4147-A177-3AD203B41FA5}">
                      <a16:colId xmlns:a16="http://schemas.microsoft.com/office/drawing/2014/main" val="3289746192"/>
                    </a:ext>
                  </a:extLst>
                </a:gridCol>
                <a:gridCol w="1041400">
                  <a:extLst>
                    <a:ext uri="{9D8B030D-6E8A-4147-A177-3AD203B41FA5}">
                      <a16:colId xmlns:a16="http://schemas.microsoft.com/office/drawing/2014/main" val="4038853626"/>
                    </a:ext>
                  </a:extLst>
                </a:gridCol>
                <a:gridCol w="1100666">
                  <a:extLst>
                    <a:ext uri="{9D8B030D-6E8A-4147-A177-3AD203B41FA5}">
                      <a16:colId xmlns:a16="http://schemas.microsoft.com/office/drawing/2014/main" val="2831548960"/>
                    </a:ext>
                  </a:extLst>
                </a:gridCol>
                <a:gridCol w="1227667">
                  <a:extLst>
                    <a:ext uri="{9D8B030D-6E8A-4147-A177-3AD203B41FA5}">
                      <a16:colId xmlns:a16="http://schemas.microsoft.com/office/drawing/2014/main" val="1672739719"/>
                    </a:ext>
                  </a:extLst>
                </a:gridCol>
                <a:gridCol w="2040467">
                  <a:extLst>
                    <a:ext uri="{9D8B030D-6E8A-4147-A177-3AD203B41FA5}">
                      <a16:colId xmlns:a16="http://schemas.microsoft.com/office/drawing/2014/main" val="797491949"/>
                    </a:ext>
                  </a:extLst>
                </a:gridCol>
                <a:gridCol w="2489200">
                  <a:extLst>
                    <a:ext uri="{9D8B030D-6E8A-4147-A177-3AD203B41FA5}">
                      <a16:colId xmlns:a16="http://schemas.microsoft.com/office/drawing/2014/main" val="172858792"/>
                    </a:ext>
                  </a:extLst>
                </a:gridCol>
                <a:gridCol w="1591735">
                  <a:extLst>
                    <a:ext uri="{9D8B030D-6E8A-4147-A177-3AD203B41FA5}">
                      <a16:colId xmlns:a16="http://schemas.microsoft.com/office/drawing/2014/main" val="3941133928"/>
                    </a:ext>
                  </a:extLst>
                </a:gridCol>
              </a:tblGrid>
              <a:tr h="80687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ompound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W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BA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BD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LogP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ipinski‘s violation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ioavailability Score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PSA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9346986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uricine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24.32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46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2.86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292042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95349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3</Words>
  <Application>Microsoft Office PowerPoint</Application>
  <PresentationFormat>宽屏</PresentationFormat>
  <Paragraphs>5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2775660672@qq.com</dc:creator>
  <cp:lastModifiedBy>2775660672@qq.com</cp:lastModifiedBy>
  <cp:revision>1</cp:revision>
  <dcterms:created xsi:type="dcterms:W3CDTF">2026-01-29T09:40:52Z</dcterms:created>
  <dcterms:modified xsi:type="dcterms:W3CDTF">2026-01-29T09:41:30Z</dcterms:modified>
</cp:coreProperties>
</file>